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6" r:id="rId2"/>
    <p:sldId id="258" r:id="rId3"/>
    <p:sldId id="257" r:id="rId4"/>
    <p:sldId id="259" r:id="rId5"/>
    <p:sldId id="261" r:id="rId6"/>
    <p:sldId id="260" r:id="rId7"/>
    <p:sldId id="262" r:id="rId8"/>
    <p:sldId id="263" r:id="rId9"/>
    <p:sldId id="264" r:id="rId10"/>
    <p:sldId id="265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1" d="100"/>
          <a:sy n="101" d="100"/>
        </p:scale>
        <p:origin x="29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EC72BB4-72BA-4B52-AF89-85DDEE272763}" type="datetimeFigureOut">
              <a:rPr lang="en-US" smtClean="0"/>
              <a:t>3/18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5559E4-08B7-43BB-9E7F-5C396CA2DC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9125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93303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7769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1096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48211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48211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2482117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5991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259913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789988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95559E4-08B7-43BB-9E7F-5C396CA2DC8B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37769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885F5E-9667-40F0-B2C2-A181315BCF59}" type="datetime1">
              <a:rPr lang="en-US" smtClean="0"/>
              <a:t>3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9920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4D798F-EB14-4EE7-99EB-938A613E728D}" type="datetime1">
              <a:rPr lang="en-US" smtClean="0"/>
              <a:t>3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0403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FC4B12-BB1A-40D5-9F8B-E0E2297F0AB2}" type="datetime1">
              <a:rPr lang="en-US" smtClean="0"/>
              <a:t>3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049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ABD059-71A0-416D-AD56-496FF050FC56}" type="datetime1">
              <a:rPr lang="en-US" smtClean="0"/>
              <a:t>3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488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85D1FF-ABAA-43C5-A16B-438645E0B571}" type="datetime1">
              <a:rPr lang="en-US" smtClean="0"/>
              <a:t>3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1027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3BCBC9-A87F-4CE9-BF0C-3492A1EAE4E7}" type="datetime1">
              <a:rPr lang="en-US" smtClean="0"/>
              <a:t>3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470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BA0C9D-BDA1-4AD0-BA8C-211D8C6DE48C}" type="datetime1">
              <a:rPr lang="en-US" smtClean="0"/>
              <a:t>3/18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3C065-8591-4D38-AEC4-F4AEB995F834}" type="datetime1">
              <a:rPr lang="en-US" smtClean="0"/>
              <a:t>3/18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3937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8F2AB0-18D3-4425-AED4-6041C7675BC9}" type="datetime1">
              <a:rPr lang="en-US" smtClean="0"/>
              <a:t>3/18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3280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61A16B-E19F-455A-8AFF-64D31C344F3D}" type="datetime1">
              <a:rPr lang="en-US" smtClean="0"/>
              <a:t>3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5208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4C9DDE-81D2-41D5-AD9E-16D889E08B17}" type="datetime1">
              <a:rPr lang="en-US" smtClean="0"/>
              <a:t>3/18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CGEA Workshop_SNIPPET TEMPLATE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987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99969B-E781-4FEB-8362-CF05245AC2B2}" type="datetime1">
              <a:rPr lang="en-US" smtClean="0"/>
              <a:t>3/18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CGEA Workshop_SNIPPET TEMPLAT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53A782-8A20-4E52-8E56-16623A0C9C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9232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Title Slide [slide 1]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99523612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se as needed </a:t>
            </a:r>
            <a:r>
              <a:rPr lang="en-US"/>
              <a:t>[slide 10]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40848740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Learning Objectives [slide 2]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6829083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dactic [slide 3]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299490652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dactic [slide 4]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10062308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dactic [slide 5]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16991685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ctivity Instructions [slide 6]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184572713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ctivity Debrief [slide 7]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32611245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Take Home Points [slide 8]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254276869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se as needed [slide 9]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SNIPPET TEMPLATE</a:t>
            </a:r>
          </a:p>
        </p:txBody>
      </p:sp>
    </p:spTree>
    <p:extLst>
      <p:ext uri="{BB962C8B-B14F-4D97-AF65-F5344CB8AC3E}">
        <p14:creationId xmlns:p14="http://schemas.microsoft.com/office/powerpoint/2010/main" val="3733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90</Words>
  <Application>Microsoft Office PowerPoint</Application>
  <PresentationFormat>On-screen Show (4:3)</PresentationFormat>
  <Paragraphs>30</Paragraphs>
  <Slides>10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3" baseType="lpstr">
      <vt:lpstr>Arial</vt:lpstr>
      <vt:lpstr>Calibri</vt:lpstr>
      <vt:lpstr>Office Theme</vt:lpstr>
      <vt:lpstr>Title Slide [slide 1]</vt:lpstr>
      <vt:lpstr>Learning Objectives [slide 2]</vt:lpstr>
      <vt:lpstr>Didactic [slide 3]</vt:lpstr>
      <vt:lpstr>Didactic [slide 4]</vt:lpstr>
      <vt:lpstr>Didactic [slide 5]</vt:lpstr>
      <vt:lpstr>Activity Instructions [slide 6]</vt:lpstr>
      <vt:lpstr>Activity Debrief [slide 7]</vt:lpstr>
      <vt:lpstr>Take Home Points [slide 8]</vt:lpstr>
      <vt:lpstr>Use as needed [slide 9]</vt:lpstr>
      <vt:lpstr>Use as needed [slide 10]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 Slide [slide 1]</dc:title>
  <dc:creator>Carrie A Bowler</dc:creator>
  <cp:lastModifiedBy>Bowler, Carrie A., M.S.</cp:lastModifiedBy>
  <cp:revision>3</cp:revision>
  <dcterms:created xsi:type="dcterms:W3CDTF">2019-03-26T02:54:33Z</dcterms:created>
  <dcterms:modified xsi:type="dcterms:W3CDTF">2021-03-19T04:15:39Z</dcterms:modified>
</cp:coreProperties>
</file>